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3" d="100"/>
          <a:sy n="63" d="100"/>
        </p:scale>
        <p:origin x="780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4BE9DC8-66F3-4566-BA12-0B5F80C7558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6046B45E-E655-4416-9D72-10347909674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04149B3-E703-40E9-BB2A-0F14FB2671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B13733-76F2-460F-B6F5-B17DB838187B}" type="datetimeFigureOut">
              <a:rPr lang="zh-CN" altLang="en-US" smtClean="0"/>
              <a:t>2018/1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DEE7BE7-B46F-4A67-A583-CCED6DB074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B588EAE-D5E3-4F0A-A06A-1C0F5A2410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2D1E5D-8B5C-4DED-86E2-35E8E1C538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4466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4D079E4-89C7-478F-905E-46DE34C329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3164264F-C8B5-4687-AF9B-0084FADDFED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165118E-CDA4-49F9-9B3E-C5989E83C5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B13733-76F2-460F-B6F5-B17DB838187B}" type="datetimeFigureOut">
              <a:rPr lang="zh-CN" altLang="en-US" smtClean="0"/>
              <a:t>2018/1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48D0E86-21DC-4D0E-A58E-C82B76331A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7BCD88B-E6A6-4469-8439-714B2B4DE3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2D1E5D-8B5C-4DED-86E2-35E8E1C538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451271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F502FD0F-F4C0-4926-9813-5AAD2526E54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6C6CF3A-B1CE-4B39-BB60-64131590D75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4115C7A-EEBB-45CE-A1A1-4AB0257CDB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B13733-76F2-460F-B6F5-B17DB838187B}" type="datetimeFigureOut">
              <a:rPr lang="zh-CN" altLang="en-US" smtClean="0"/>
              <a:t>2018/1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8F06B61-B41A-4E13-86EA-DE5449B50A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703D185-4EE0-4503-8F71-41B1E3A78C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2D1E5D-8B5C-4DED-86E2-35E8E1C538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333201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9587AE8-FA3C-4BB5-A8E0-C9114E40FD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04BBAD2-9E91-4E6C-852B-9264F270000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E619D69-C85C-407A-9CF4-C976A0ED58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B13733-76F2-460F-B6F5-B17DB838187B}" type="datetimeFigureOut">
              <a:rPr lang="zh-CN" altLang="en-US" smtClean="0"/>
              <a:t>2018/1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3B2381F-4FC0-4EDC-8BF9-1E3A41BBE7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7FE123C-042E-46DE-8C0B-42E9CB1AD0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2D1E5D-8B5C-4DED-86E2-35E8E1C538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34049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D8DD47E-C93D-46C6-9BF8-161311500C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C6C6D25-E932-44EF-90A5-B515EED61D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5B2CBD6-07CF-479B-B6FF-3109532E2C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B13733-76F2-460F-B6F5-B17DB838187B}" type="datetimeFigureOut">
              <a:rPr lang="zh-CN" altLang="en-US" smtClean="0"/>
              <a:t>2018/1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68BE63E-6689-4109-B6BA-4B4C18EFCA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47C1F41-A43C-4933-9B38-9E59EC45FD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2D1E5D-8B5C-4DED-86E2-35E8E1C538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10476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CD09CF4-0088-4A5A-96FA-27B26F66A2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685DFE1-7685-4BE2-9AA7-2796C6721B7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D0C3E47-2A51-4FC9-A305-24A99FDE61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1580051-F94A-4873-950B-473DAC4D12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B13733-76F2-460F-B6F5-B17DB838187B}" type="datetimeFigureOut">
              <a:rPr lang="zh-CN" altLang="en-US" smtClean="0"/>
              <a:t>2018/1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0D03192-E0EF-4DA1-8969-F4D7605A21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86E8E98-D555-4181-B6D3-D57098DD51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2D1E5D-8B5C-4DED-86E2-35E8E1C538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078238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61B495F-C1CC-4007-8C5D-C8975B4A34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F4DAA9A-95E4-457E-BF4F-3810CFE55E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EC3C0CB-7B0D-40B5-88C7-99C17266A1F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58853B9B-D134-451A-8763-3FE43F8BBA7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0175381C-5AF4-4686-988A-7953813712D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5725A107-D380-43A7-86AC-1E54E64409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B13733-76F2-460F-B6F5-B17DB838187B}" type="datetimeFigureOut">
              <a:rPr lang="zh-CN" altLang="en-US" smtClean="0"/>
              <a:t>2018/1/15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6122519-C406-44BA-9A3D-48500CC3F3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8FFA1D5F-3C28-4D7C-8295-615295218D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2D1E5D-8B5C-4DED-86E2-35E8E1C538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30214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B9BBC2C-5F62-4CD8-B76F-641769EEF0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EAEEC23D-654E-42E2-AE08-534C3A0FB0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B13733-76F2-460F-B6F5-B17DB838187B}" type="datetimeFigureOut">
              <a:rPr lang="zh-CN" altLang="en-US" smtClean="0"/>
              <a:t>2018/1/15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6C017A85-D343-4657-AC55-6C8A545CB2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C4367FC6-6B00-4804-801F-2F6CD2CA99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2D1E5D-8B5C-4DED-86E2-35E8E1C538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78642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AAE4A6F3-2788-47B4-8D3D-49490F0B0B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B13733-76F2-460F-B6F5-B17DB838187B}" type="datetimeFigureOut">
              <a:rPr lang="zh-CN" altLang="en-US" smtClean="0"/>
              <a:t>2018/1/15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4FD98496-F067-4488-A53C-7BA43AC2AE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540BDD54-7F3F-4B46-AC33-2E1C438506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2D1E5D-8B5C-4DED-86E2-35E8E1C538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68006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B518463-D872-45F5-BE84-21A743E725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5BB8EDC-4AEA-40DA-A83D-22B7134D42C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FE966B1-23ED-4390-9B81-3B033808CF3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CDE333B-87A7-4F18-A9E9-12C93A066C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B13733-76F2-460F-B6F5-B17DB838187B}" type="datetimeFigureOut">
              <a:rPr lang="zh-CN" altLang="en-US" smtClean="0"/>
              <a:t>2018/1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5A02D6D-9793-4C26-9F9B-C0009223F7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43837CE-3FEF-43DE-AEB1-FFF494B19A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2D1E5D-8B5C-4DED-86E2-35E8E1C538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92439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DC5CDB4-11B2-49AF-B11E-AF91970DC0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0F183FF6-1C5F-4138-BD23-E06E193BAA4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F98585D-A6DA-4067-928E-3193DAA3D2C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D796AC2-2BA8-4F67-8A1E-D4A9BFE653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B13733-76F2-460F-B6F5-B17DB838187B}" type="datetimeFigureOut">
              <a:rPr lang="zh-CN" altLang="en-US" smtClean="0"/>
              <a:t>2018/1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3855666-8BFB-4ED5-A1E6-DF222AA8C1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0BE8F24-1A75-471C-8630-A8225A867E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2D1E5D-8B5C-4DED-86E2-35E8E1C538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183645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7F0CC9B3-77D2-4EE7-9487-70EA10C41C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DCF9AA2-6681-4E61-BAFE-01151737D8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F6AFC86-0EC9-4B8B-996C-86CDAA79BB7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B13733-76F2-460F-B6F5-B17DB838187B}" type="datetimeFigureOut">
              <a:rPr lang="zh-CN" altLang="en-US" smtClean="0"/>
              <a:t>2018/1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05A37FD-7C78-4BF9-A2F7-64760E9384F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795248C-C7D6-40AD-9623-55DE20715A4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2D1E5D-8B5C-4DED-86E2-35E8E1C538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39355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>
            <a:extLst>
              <a:ext uri="{FF2B5EF4-FFF2-40B4-BE49-F238E27FC236}">
                <a16:creationId xmlns:a16="http://schemas.microsoft.com/office/drawing/2014/main" id="{38C05D41-3060-4B8E-A266-FAFEA4813081}"/>
              </a:ext>
            </a:extLst>
          </p:cNvPr>
          <p:cNvSpPr txBox="1"/>
          <p:nvPr/>
        </p:nvSpPr>
        <p:spPr>
          <a:xfrm>
            <a:off x="772160" y="660400"/>
            <a:ext cx="4978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7C519942-13B0-4E98-92A9-6E64CEAB977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05000" y="0"/>
            <a:ext cx="838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783490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176473A3-4173-41DB-BBE9-D4A08233E8CA}"/>
              </a:ext>
            </a:extLst>
          </p:cNvPr>
          <p:cNvSpPr txBox="1"/>
          <p:nvPr/>
        </p:nvSpPr>
        <p:spPr>
          <a:xfrm>
            <a:off x="9712959" y="5207000"/>
            <a:ext cx="247904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The replicates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DE (A and B).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60D1028F-FDE3-4B98-8804-82C1526AD9C5}"/>
              </a:ext>
            </a:extLst>
          </p:cNvPr>
          <p:cNvSpPr txBox="1"/>
          <p:nvPr/>
        </p:nvSpPr>
        <p:spPr>
          <a:xfrm>
            <a:off x="965200" y="436880"/>
            <a:ext cx="4673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内容占位符 7">
            <a:extLst>
              <a:ext uri="{FF2B5EF4-FFF2-40B4-BE49-F238E27FC236}">
                <a16:creationId xmlns:a16="http://schemas.microsoft.com/office/drawing/2014/main" id="{3FCC8D6B-CC78-4B36-BDBE-B4BDF59592F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32560" y="0"/>
            <a:ext cx="8382000" cy="6858000"/>
          </a:xfrm>
        </p:spPr>
      </p:pic>
    </p:spTree>
    <p:extLst>
      <p:ext uri="{BB962C8B-B14F-4D97-AF65-F5344CB8AC3E}">
        <p14:creationId xmlns:p14="http://schemas.microsoft.com/office/powerpoint/2010/main" val="181136857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文本框 11">
            <a:extLst>
              <a:ext uri="{FF2B5EF4-FFF2-40B4-BE49-F238E27FC236}">
                <a16:creationId xmlns:a16="http://schemas.microsoft.com/office/drawing/2014/main" id="{907BC85F-7749-48C2-997B-D9FF9E2BE7F1}"/>
              </a:ext>
            </a:extLst>
          </p:cNvPr>
          <p:cNvSpPr txBox="1"/>
          <p:nvPr/>
        </p:nvSpPr>
        <p:spPr>
          <a:xfrm>
            <a:off x="2834640" y="5618480"/>
            <a:ext cx="49987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The replicates of Rubisco Western Blot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内容占位符 4">
            <a:extLst>
              <a:ext uri="{FF2B5EF4-FFF2-40B4-BE49-F238E27FC236}">
                <a16:creationId xmlns:a16="http://schemas.microsoft.com/office/drawing/2014/main" id="{15DFF19F-4160-411C-A5B3-D9AD0D278026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2385035"/>
            <a:ext cx="10515600" cy="2644689"/>
          </a:xfr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FCFDDC24-1B1A-4948-9BC8-E124B70064BD}"/>
              </a:ext>
            </a:extLst>
          </p:cNvPr>
          <p:cNvSpPr txBox="1"/>
          <p:nvPr/>
        </p:nvSpPr>
        <p:spPr>
          <a:xfrm>
            <a:off x="1991360" y="4775200"/>
            <a:ext cx="966216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-28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℃   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c-28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℃      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-42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℃    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c-42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℃       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-28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℃      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c-28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℃     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-42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℃     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c-42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℃</a:t>
            </a:r>
          </a:p>
          <a:p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5071564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9F3204CF-AFB4-4941-8CD7-4C79415E3A43}"/>
              </a:ext>
            </a:extLst>
          </p:cNvPr>
          <p:cNvSpPr txBox="1"/>
          <p:nvPr/>
        </p:nvSpPr>
        <p:spPr>
          <a:xfrm>
            <a:off x="3499858" y="5679440"/>
            <a:ext cx="45923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The replicates of OEE1 Western Blot.</a:t>
            </a:r>
            <a:endParaRPr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946AE358-04CD-423E-8BA9-4F44421C1884}"/>
              </a:ext>
            </a:extLst>
          </p:cNvPr>
          <p:cNvSpPr txBox="1"/>
          <p:nvPr/>
        </p:nvSpPr>
        <p:spPr>
          <a:xfrm>
            <a:off x="1991360" y="4775200"/>
            <a:ext cx="966216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-28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℃   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c-28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℃     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-42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℃    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c-42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℃       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-28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℃      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c-28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℃     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-42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℃     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c-42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℃</a:t>
            </a:r>
          </a:p>
          <a:p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内容占位符 6">
            <a:extLst>
              <a:ext uri="{FF2B5EF4-FFF2-40B4-BE49-F238E27FC236}">
                <a16:creationId xmlns:a16="http://schemas.microsoft.com/office/drawing/2014/main" id="{59CE2833-C50D-4177-9458-ECBBBF825E50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2857213"/>
            <a:ext cx="10515600" cy="2010959"/>
          </a:xfrm>
        </p:spPr>
      </p:pic>
    </p:spTree>
    <p:extLst>
      <p:ext uri="{BB962C8B-B14F-4D97-AF65-F5344CB8AC3E}">
        <p14:creationId xmlns:p14="http://schemas.microsoft.com/office/powerpoint/2010/main" val="30718420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9</TotalTime>
  <Words>66</Words>
  <Application>Microsoft Office PowerPoint</Application>
  <PresentationFormat>宽屏</PresentationFormat>
  <Paragraphs>7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9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徐烨</dc:creator>
  <cp:lastModifiedBy>徐烨</cp:lastModifiedBy>
  <cp:revision>17</cp:revision>
  <dcterms:created xsi:type="dcterms:W3CDTF">2017-11-11T04:11:12Z</dcterms:created>
  <dcterms:modified xsi:type="dcterms:W3CDTF">2018-01-15T01:38:41Z</dcterms:modified>
</cp:coreProperties>
</file>